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>
      <p:cViewPr varScale="1">
        <p:scale>
          <a:sx n="60" d="100"/>
          <a:sy n="60" d="100"/>
        </p:scale>
        <p:origin x="2467" y="5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914400" cy="9144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6682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46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1273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4817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6920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8991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5452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96017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0163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4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5628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6AE58-4559-48F0-9C41-6FC478CF49C5}" type="datetimeFigureOut">
              <a:rPr lang="en-US" smtClean="0"/>
              <a:t>12/20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027E54-847C-4A99-BD17-641BFA91B19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0297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54">
            <a:extLst>
              <a:ext uri="{FF2B5EF4-FFF2-40B4-BE49-F238E27FC236}">
                <a16:creationId xmlns:a16="http://schemas.microsoft.com/office/drawing/2014/main" id="{B118621B-F3E0-4C0A-B9E4-FF2E441154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5771" y="7284840"/>
            <a:ext cx="4339063" cy="1092147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0013B00E-CE89-4697-8F0F-7BCE8E678C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0466" y="3711805"/>
            <a:ext cx="4340408" cy="126198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8E59661-05FF-4AC0-A1F3-6432F9F872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72029" y="1783444"/>
            <a:ext cx="4338845" cy="1697786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710B93EE-B51B-447D-866C-329BCC18F7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70466" y="5617047"/>
            <a:ext cx="4260493" cy="129285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7DE189F-0A2A-4012-BE84-B9217EDC1139}"/>
              </a:ext>
            </a:extLst>
          </p:cNvPr>
          <p:cNvSpPr txBox="1"/>
          <p:nvPr/>
        </p:nvSpPr>
        <p:spPr>
          <a:xfrm>
            <a:off x="685800" y="870971"/>
            <a:ext cx="182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6 A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5B6370B-F707-472E-B331-744418C38798}"/>
              </a:ext>
            </a:extLst>
          </p:cNvPr>
          <p:cNvSpPr txBox="1"/>
          <p:nvPr/>
        </p:nvSpPr>
        <p:spPr>
          <a:xfrm>
            <a:off x="698252" y="3498264"/>
            <a:ext cx="548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2) The expression of EGFR following treatment with 15% krill oil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56A8B55-F957-42E8-8755-DA6EE6F953D3}"/>
              </a:ext>
            </a:extLst>
          </p:cNvPr>
          <p:cNvSpPr txBox="1"/>
          <p:nvPr/>
        </p:nvSpPr>
        <p:spPr>
          <a:xfrm>
            <a:off x="707447" y="1326523"/>
            <a:ext cx="548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1) The expression of pEGFR following treatment with 15% krill oil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87929EA-8654-4E91-BB80-688B8F044CCC}"/>
              </a:ext>
            </a:extLst>
          </p:cNvPr>
          <p:cNvSpPr txBox="1"/>
          <p:nvPr/>
        </p:nvSpPr>
        <p:spPr>
          <a:xfrm>
            <a:off x="179290" y="8295534"/>
            <a:ext cx="656110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rabicParenBoth"/>
            </a:pPr>
            <a:r>
              <a:rPr lang="en-US" sz="1100" dirty="0"/>
              <a:t>&amp; (2) The expression of pEGFR and EGFR analyzed by western blotting in tumours following treatment </a:t>
            </a:r>
          </a:p>
          <a:p>
            <a:r>
              <a:rPr lang="en-US" sz="1100" dirty="0"/>
              <a:t>       with  15% krill oil compared to the untreated group.</a:t>
            </a:r>
          </a:p>
          <a:p>
            <a:pPr marL="231775" indent="-231775"/>
            <a:r>
              <a:rPr lang="en-US" sz="1100" dirty="0"/>
              <a:t>(3) The expression of pAKT analyzed by western blotting in tumours following treatment with 15% krill oil compared to the untreated group.</a:t>
            </a:r>
          </a:p>
          <a:p>
            <a:pPr marL="231775" indent="-231775"/>
            <a:r>
              <a:rPr lang="en-US" sz="1100" dirty="0"/>
              <a:t>(4) The expression of AKT analyzed by western blotting in tumours following treatment with 15% krill oil compared to the untreated group.</a:t>
            </a:r>
          </a:p>
          <a:p>
            <a:endParaRPr lang="en-US" sz="11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38B271C-EB88-4F45-A7EF-9D46CE33F04B}"/>
              </a:ext>
            </a:extLst>
          </p:cNvPr>
          <p:cNvSpPr txBox="1"/>
          <p:nvPr/>
        </p:nvSpPr>
        <p:spPr>
          <a:xfrm>
            <a:off x="732133" y="5070296"/>
            <a:ext cx="54400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3) The expression of pAKT following treatment with 15% krill oil.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ED3C8D0-5D56-4029-8708-295B3A1103BD}"/>
              </a:ext>
            </a:extLst>
          </p:cNvPr>
          <p:cNvSpPr txBox="1"/>
          <p:nvPr/>
        </p:nvSpPr>
        <p:spPr>
          <a:xfrm>
            <a:off x="698252" y="6938546"/>
            <a:ext cx="548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4) The expression of AKT following treatment with 15% krill oil.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6B51655-8CA4-4E28-A0B1-BAFD816931C8}"/>
              </a:ext>
            </a:extLst>
          </p:cNvPr>
          <p:cNvSpPr txBox="1"/>
          <p:nvPr/>
        </p:nvSpPr>
        <p:spPr>
          <a:xfrm rot="16200000">
            <a:off x="4046974" y="7161729"/>
            <a:ext cx="89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Untreated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7F1DB29-41D7-4B3E-A64C-ACDFECB5CF5E}"/>
              </a:ext>
            </a:extLst>
          </p:cNvPr>
          <p:cNvSpPr txBox="1"/>
          <p:nvPr/>
        </p:nvSpPr>
        <p:spPr>
          <a:xfrm rot="16200000">
            <a:off x="4358929" y="7078849"/>
            <a:ext cx="900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15% KO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E71BD787-0D50-42C8-BA8C-42B15D2E9DA9}"/>
              </a:ext>
            </a:extLst>
          </p:cNvPr>
          <p:cNvGrpSpPr/>
          <p:nvPr/>
        </p:nvGrpSpPr>
        <p:grpSpPr>
          <a:xfrm>
            <a:off x="677372" y="1423952"/>
            <a:ext cx="4032816" cy="1161769"/>
            <a:chOff x="341242" y="1515041"/>
            <a:chExt cx="4032816" cy="1161769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DA6045B-0676-44BC-BD86-26605C5646FE}"/>
                </a:ext>
              </a:extLst>
            </p:cNvPr>
            <p:cNvSpPr txBox="1"/>
            <p:nvPr/>
          </p:nvSpPr>
          <p:spPr>
            <a:xfrm>
              <a:off x="341242" y="2276700"/>
              <a:ext cx="8060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pEGFR</a:t>
              </a:r>
            </a:p>
            <a:p>
              <a:r>
                <a:rPr lang="en-AU" sz="1000" dirty="0"/>
                <a:t>175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A6E5543-414B-4DC9-A724-F641AE9AD2E6}"/>
                </a:ext>
              </a:extLst>
            </p:cNvPr>
            <p:cNvSpPr txBox="1"/>
            <p:nvPr/>
          </p:nvSpPr>
          <p:spPr>
            <a:xfrm rot="16200000">
              <a:off x="3819815" y="1884601"/>
              <a:ext cx="8622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15% KO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1D449B0-B95D-40F0-BA83-D18318B6CE5E}"/>
                </a:ext>
              </a:extLst>
            </p:cNvPr>
            <p:cNvSpPr txBox="1"/>
            <p:nvPr/>
          </p:nvSpPr>
          <p:spPr>
            <a:xfrm rot="16200000">
              <a:off x="3535679" y="1841252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Untreated</a:t>
              </a:r>
            </a:p>
          </p:txBody>
        </p: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6ECC0520-7142-48B7-A080-5716973B19FF}"/>
                </a:ext>
              </a:extLst>
            </p:cNvPr>
            <p:cNvCxnSpPr>
              <a:cxnSpLocks/>
            </p:cNvCxnSpPr>
            <p:nvPr/>
          </p:nvCxnSpPr>
          <p:spPr>
            <a:xfrm>
              <a:off x="817593" y="2554358"/>
              <a:ext cx="36777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AF94E573-EEE3-42CC-A0F3-E171B0B53A70}"/>
              </a:ext>
            </a:extLst>
          </p:cNvPr>
          <p:cNvGrpSpPr/>
          <p:nvPr/>
        </p:nvGrpSpPr>
        <p:grpSpPr>
          <a:xfrm>
            <a:off x="805794" y="3405502"/>
            <a:ext cx="4472683" cy="1183038"/>
            <a:chOff x="805793" y="3379803"/>
            <a:chExt cx="4472683" cy="1183038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9B6125B-E941-46E4-91F8-B3F6BEC8D7CB}"/>
                </a:ext>
              </a:extLst>
            </p:cNvPr>
            <p:cNvSpPr txBox="1"/>
            <p:nvPr/>
          </p:nvSpPr>
          <p:spPr>
            <a:xfrm rot="16200000">
              <a:off x="4378864" y="3753223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Untreated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187B337-EBE1-49F5-AA93-AA198DA01914}"/>
                </a:ext>
              </a:extLst>
            </p:cNvPr>
            <p:cNvSpPr txBox="1"/>
            <p:nvPr/>
          </p:nvSpPr>
          <p:spPr>
            <a:xfrm rot="16200000">
              <a:off x="4705260" y="3706798"/>
              <a:ext cx="9002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15% KO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559D6E2-37F7-4D54-88FD-30ABA657AEAE}"/>
                </a:ext>
              </a:extLst>
            </p:cNvPr>
            <p:cNvSpPr txBox="1"/>
            <p:nvPr/>
          </p:nvSpPr>
          <p:spPr>
            <a:xfrm>
              <a:off x="805793" y="4162731"/>
              <a:ext cx="8060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EGFR</a:t>
              </a:r>
            </a:p>
            <a:p>
              <a:r>
                <a:rPr lang="en-AU" sz="1000" dirty="0"/>
                <a:t>180kDa</a:t>
              </a:r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70EA6F44-BADE-4967-BC31-FD36DC824E36}"/>
                </a:ext>
              </a:extLst>
            </p:cNvPr>
            <p:cNvCxnSpPr>
              <a:cxnSpLocks/>
            </p:cNvCxnSpPr>
            <p:nvPr/>
          </p:nvCxnSpPr>
          <p:spPr>
            <a:xfrm>
              <a:off x="1340746" y="4416952"/>
              <a:ext cx="36777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DD3536AF-AA0F-4B26-B64F-89F931D8A367}"/>
              </a:ext>
            </a:extLst>
          </p:cNvPr>
          <p:cNvGrpSpPr/>
          <p:nvPr/>
        </p:nvGrpSpPr>
        <p:grpSpPr>
          <a:xfrm>
            <a:off x="828210" y="4814094"/>
            <a:ext cx="4558037" cy="1346478"/>
            <a:chOff x="828210" y="4814094"/>
            <a:chExt cx="4558037" cy="1346478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4D37C8A-1205-4877-BF74-6D14814CF022}"/>
                </a:ext>
              </a:extLst>
            </p:cNvPr>
            <p:cNvSpPr txBox="1"/>
            <p:nvPr/>
          </p:nvSpPr>
          <p:spPr>
            <a:xfrm>
              <a:off x="828210" y="5760462"/>
              <a:ext cx="8060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pAKT</a:t>
              </a:r>
            </a:p>
            <a:p>
              <a:r>
                <a:rPr lang="en-AU" sz="1000" dirty="0"/>
                <a:t>56kD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82C2CAE-7910-4DB3-ABDD-FF45352E3687}"/>
                </a:ext>
              </a:extLst>
            </p:cNvPr>
            <p:cNvSpPr txBox="1"/>
            <p:nvPr/>
          </p:nvSpPr>
          <p:spPr>
            <a:xfrm rot="16200000">
              <a:off x="4589188" y="5247511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Untreated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637C11E-8E66-48B0-806D-E052E0DD6536}"/>
                </a:ext>
              </a:extLst>
            </p:cNvPr>
            <p:cNvSpPr txBox="1"/>
            <p:nvPr/>
          </p:nvSpPr>
          <p:spPr>
            <a:xfrm rot="16200000">
              <a:off x="4813031" y="5141089"/>
              <a:ext cx="9002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15% KO</a:t>
              </a: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C7982416-F71C-4F95-B751-B03C46F148A6}"/>
                </a:ext>
              </a:extLst>
            </p:cNvPr>
            <p:cNvCxnSpPr>
              <a:cxnSpLocks/>
            </p:cNvCxnSpPr>
            <p:nvPr/>
          </p:nvCxnSpPr>
          <p:spPr>
            <a:xfrm>
              <a:off x="1208821" y="5960517"/>
              <a:ext cx="36777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16653891-EEA9-47B2-9CC9-736DA76223B3}"/>
              </a:ext>
            </a:extLst>
          </p:cNvPr>
          <p:cNvSpPr txBox="1"/>
          <p:nvPr/>
        </p:nvSpPr>
        <p:spPr>
          <a:xfrm>
            <a:off x="828210" y="7430804"/>
            <a:ext cx="8060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AKT</a:t>
            </a:r>
          </a:p>
          <a:p>
            <a:r>
              <a:rPr lang="en-AU" sz="1000" dirty="0"/>
              <a:t>60kDa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26EA4B26-1994-4507-AD1D-C35B2E48F085}"/>
              </a:ext>
            </a:extLst>
          </p:cNvPr>
          <p:cNvCxnSpPr/>
          <p:nvPr/>
        </p:nvCxnSpPr>
        <p:spPr>
          <a:xfrm>
            <a:off x="4323591" y="2247177"/>
            <a:ext cx="0" cy="2411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E00357B8-8249-45F0-9D46-0F78863F6E6A}"/>
              </a:ext>
            </a:extLst>
          </p:cNvPr>
          <p:cNvCxnSpPr/>
          <p:nvPr/>
        </p:nvCxnSpPr>
        <p:spPr>
          <a:xfrm>
            <a:off x="4587078" y="2265091"/>
            <a:ext cx="0" cy="2411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D37F03B0-66D8-4666-B1CD-CA5E1EAFDFB1}"/>
              </a:ext>
            </a:extLst>
          </p:cNvPr>
          <p:cNvCxnSpPr/>
          <p:nvPr/>
        </p:nvCxnSpPr>
        <p:spPr>
          <a:xfrm>
            <a:off x="4834281" y="4226357"/>
            <a:ext cx="0" cy="2411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A462BC0F-CFB3-41F8-AE97-5B8131F1AE9E}"/>
              </a:ext>
            </a:extLst>
          </p:cNvPr>
          <p:cNvCxnSpPr/>
          <p:nvPr/>
        </p:nvCxnSpPr>
        <p:spPr>
          <a:xfrm>
            <a:off x="5167192" y="4222220"/>
            <a:ext cx="0" cy="2411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40">
            <a:extLst>
              <a:ext uri="{FF2B5EF4-FFF2-40B4-BE49-F238E27FC236}">
                <a16:creationId xmlns:a16="http://schemas.microsoft.com/office/drawing/2014/main" id="{08A110D0-C941-4EF8-B5A1-F826426CBAD1}"/>
              </a:ext>
            </a:extLst>
          </p:cNvPr>
          <p:cNvSpPr/>
          <p:nvPr/>
        </p:nvSpPr>
        <p:spPr>
          <a:xfrm>
            <a:off x="4167611" y="2487292"/>
            <a:ext cx="542577" cy="2062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D159C419-A883-4420-A8EC-4A593462439E}"/>
              </a:ext>
            </a:extLst>
          </p:cNvPr>
          <p:cNvSpPr/>
          <p:nvPr/>
        </p:nvSpPr>
        <p:spPr>
          <a:xfrm>
            <a:off x="4747726" y="4281387"/>
            <a:ext cx="542577" cy="3329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F2A9684B-DB1D-4850-A692-CE3D024A285B}"/>
              </a:ext>
            </a:extLst>
          </p:cNvPr>
          <p:cNvCxnSpPr/>
          <p:nvPr/>
        </p:nvCxnSpPr>
        <p:spPr>
          <a:xfrm>
            <a:off x="5273850" y="5681723"/>
            <a:ext cx="0" cy="2411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6449F3C3-3CA8-4951-9249-D7EA5E870B65}"/>
              </a:ext>
            </a:extLst>
          </p:cNvPr>
          <p:cNvCxnSpPr/>
          <p:nvPr/>
        </p:nvCxnSpPr>
        <p:spPr>
          <a:xfrm>
            <a:off x="5053363" y="5719368"/>
            <a:ext cx="0" cy="2411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6D2864A4-96C0-4824-A68F-FC74F612B51B}"/>
              </a:ext>
            </a:extLst>
          </p:cNvPr>
          <p:cNvSpPr/>
          <p:nvPr/>
        </p:nvSpPr>
        <p:spPr>
          <a:xfrm>
            <a:off x="4904667" y="5783276"/>
            <a:ext cx="542577" cy="3329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9B54F5DE-4F5C-485C-8738-D7E15A4A8ED0}"/>
              </a:ext>
            </a:extLst>
          </p:cNvPr>
          <p:cNvCxnSpPr>
            <a:cxnSpLocks/>
          </p:cNvCxnSpPr>
          <p:nvPr/>
        </p:nvCxnSpPr>
        <p:spPr>
          <a:xfrm>
            <a:off x="1115656" y="7592942"/>
            <a:ext cx="36777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30D1725D-3872-4BDE-8F5B-08E3900B7C0B}"/>
              </a:ext>
            </a:extLst>
          </p:cNvPr>
          <p:cNvCxnSpPr/>
          <p:nvPr/>
        </p:nvCxnSpPr>
        <p:spPr>
          <a:xfrm>
            <a:off x="4438899" y="7389710"/>
            <a:ext cx="0" cy="2411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E6FA60C9-3729-4E06-914C-D20B7FB2CA27}"/>
              </a:ext>
            </a:extLst>
          </p:cNvPr>
          <p:cNvCxnSpPr/>
          <p:nvPr/>
        </p:nvCxnSpPr>
        <p:spPr>
          <a:xfrm>
            <a:off x="4705076" y="7410917"/>
            <a:ext cx="0" cy="2411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tangle 53">
            <a:extLst>
              <a:ext uri="{FF2B5EF4-FFF2-40B4-BE49-F238E27FC236}">
                <a16:creationId xmlns:a16="http://schemas.microsoft.com/office/drawing/2014/main" id="{2E3D5BE4-99FF-4AA0-88BD-596556A67217}"/>
              </a:ext>
            </a:extLst>
          </p:cNvPr>
          <p:cNvSpPr/>
          <p:nvPr/>
        </p:nvSpPr>
        <p:spPr>
          <a:xfrm>
            <a:off x="4333330" y="7635033"/>
            <a:ext cx="542577" cy="1280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32442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DC7088F8-A3F1-4655-9671-88D804EE6E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8034" y="6185137"/>
            <a:ext cx="3925486" cy="1225296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2A293FB9-9F8B-45C8-8949-ED7A80C929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8035" y="4262484"/>
            <a:ext cx="3925486" cy="1143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325FCD9-69BC-417E-AA1C-55024BDED21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58034" y="2112745"/>
            <a:ext cx="3925486" cy="122529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68D006F-250D-4AFB-855B-9A0018D3B18F}"/>
              </a:ext>
            </a:extLst>
          </p:cNvPr>
          <p:cNvSpPr txBox="1"/>
          <p:nvPr/>
        </p:nvSpPr>
        <p:spPr>
          <a:xfrm>
            <a:off x="606583" y="1329769"/>
            <a:ext cx="548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5) The expression of pERK following treatment with 15% krill oil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BCA32FF-08DB-4FC5-999B-821317D6EB46}"/>
              </a:ext>
            </a:extLst>
          </p:cNvPr>
          <p:cNvSpPr txBox="1"/>
          <p:nvPr/>
        </p:nvSpPr>
        <p:spPr>
          <a:xfrm>
            <a:off x="685800" y="3912284"/>
            <a:ext cx="548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6) The expression of ERK following treatment with 15% krill oil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6CE9F37-7045-4878-98CB-7B531A7DECA8}"/>
              </a:ext>
            </a:extLst>
          </p:cNvPr>
          <p:cNvSpPr txBox="1"/>
          <p:nvPr/>
        </p:nvSpPr>
        <p:spPr>
          <a:xfrm>
            <a:off x="685800" y="5731562"/>
            <a:ext cx="548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7) The expression of GAPDH following treatment with 15% krill oil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A426EA50-EC33-4044-8D51-E69D826FA721}"/>
              </a:ext>
            </a:extLst>
          </p:cNvPr>
          <p:cNvGrpSpPr/>
          <p:nvPr/>
        </p:nvGrpSpPr>
        <p:grpSpPr>
          <a:xfrm>
            <a:off x="1188614" y="3890635"/>
            <a:ext cx="3548062" cy="1195068"/>
            <a:chOff x="1188614" y="3890635"/>
            <a:chExt cx="3548062" cy="1195068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0D2D9B7-03B0-4601-B438-98E8B004A20B}"/>
                </a:ext>
              </a:extLst>
            </p:cNvPr>
            <p:cNvSpPr txBox="1"/>
            <p:nvPr/>
          </p:nvSpPr>
          <p:spPr>
            <a:xfrm rot="16200000">
              <a:off x="3931106" y="4220055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Untreated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182DFAF-4C2E-40DE-91E8-8DE66BF9ABD5}"/>
                </a:ext>
              </a:extLst>
            </p:cNvPr>
            <p:cNvSpPr txBox="1"/>
            <p:nvPr/>
          </p:nvSpPr>
          <p:spPr>
            <a:xfrm>
              <a:off x="1188614" y="4685593"/>
              <a:ext cx="8060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ERK</a:t>
              </a:r>
            </a:p>
            <a:p>
              <a:r>
                <a:rPr lang="en-AU" sz="1000" dirty="0"/>
                <a:t>44kD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BA5FB32-7180-42E8-99D6-45FA1D98E00A}"/>
                </a:ext>
              </a:extLst>
            </p:cNvPr>
            <p:cNvSpPr txBox="1"/>
            <p:nvPr/>
          </p:nvSpPr>
          <p:spPr>
            <a:xfrm rot="16200000">
              <a:off x="4164244" y="4216846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15% KO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17727E4C-9F3C-4D54-B972-98D4E64CB71A}"/>
              </a:ext>
            </a:extLst>
          </p:cNvPr>
          <p:cNvSpPr txBox="1"/>
          <p:nvPr/>
        </p:nvSpPr>
        <p:spPr>
          <a:xfrm>
            <a:off x="685799" y="7703905"/>
            <a:ext cx="548640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31775" indent="-231775"/>
            <a:r>
              <a:rPr lang="en-US" sz="1200" dirty="0"/>
              <a:t>(5) &amp; (6) The expression of pERK and ERK analyzed by western blotting in tumours following treatment with 15% krill oil compared to the untreated group.  </a:t>
            </a:r>
          </a:p>
          <a:p>
            <a:endParaRPr lang="en-US" sz="1200" dirty="0"/>
          </a:p>
          <a:p>
            <a:pPr marL="231775" indent="-231775"/>
            <a:r>
              <a:rPr lang="en-US" sz="1200" dirty="0"/>
              <a:t>(7) The expression of GAPDH in tumours following treatment with 15% krill oil  compared to the untreated group.</a:t>
            </a:r>
          </a:p>
          <a:p>
            <a:endParaRPr lang="en-US" sz="1200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91DF93D-5EE1-4B09-BE77-6083B14E04C9}"/>
              </a:ext>
            </a:extLst>
          </p:cNvPr>
          <p:cNvGrpSpPr/>
          <p:nvPr/>
        </p:nvGrpSpPr>
        <p:grpSpPr>
          <a:xfrm>
            <a:off x="920955" y="1329769"/>
            <a:ext cx="3692610" cy="1303011"/>
            <a:chOff x="907716" y="1468268"/>
            <a:chExt cx="3692610" cy="1303011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0FBCBC0-5524-461D-BE3B-F67EAABA4930}"/>
                </a:ext>
              </a:extLst>
            </p:cNvPr>
            <p:cNvSpPr txBox="1"/>
            <p:nvPr/>
          </p:nvSpPr>
          <p:spPr>
            <a:xfrm>
              <a:off x="907716" y="2371169"/>
              <a:ext cx="8060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pERK</a:t>
              </a:r>
            </a:p>
            <a:p>
              <a:r>
                <a:rPr lang="en-AU" sz="1000" dirty="0"/>
                <a:t>130kD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7820BC7-C527-438C-BCDD-95B66CA3848B}"/>
                </a:ext>
              </a:extLst>
            </p:cNvPr>
            <p:cNvSpPr txBox="1"/>
            <p:nvPr/>
          </p:nvSpPr>
          <p:spPr>
            <a:xfrm rot="16200000">
              <a:off x="3815360" y="1838276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Untreate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EF17472-7141-4147-BB91-CB3CF88820EE}"/>
                </a:ext>
              </a:extLst>
            </p:cNvPr>
            <p:cNvSpPr txBox="1"/>
            <p:nvPr/>
          </p:nvSpPr>
          <p:spPr>
            <a:xfrm rot="16200000">
              <a:off x="4027894" y="1794479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15% KO</a:t>
              </a: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981C5E2A-24D8-4423-BBEC-51098DC6ED04}"/>
                </a:ext>
              </a:extLst>
            </p:cNvPr>
            <p:cNvCxnSpPr>
              <a:cxnSpLocks/>
            </p:cNvCxnSpPr>
            <p:nvPr/>
          </p:nvCxnSpPr>
          <p:spPr>
            <a:xfrm>
              <a:off x="1310743" y="2571224"/>
              <a:ext cx="36777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782D13F6-EA00-4E7A-9C3D-F66F8AC23870}"/>
              </a:ext>
            </a:extLst>
          </p:cNvPr>
          <p:cNvCxnSpPr>
            <a:cxnSpLocks/>
          </p:cNvCxnSpPr>
          <p:nvPr/>
        </p:nvCxnSpPr>
        <p:spPr>
          <a:xfrm>
            <a:off x="1458034" y="4895394"/>
            <a:ext cx="36777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" name="Group 3">
            <a:extLst>
              <a:ext uri="{FF2B5EF4-FFF2-40B4-BE49-F238E27FC236}">
                <a16:creationId xmlns:a16="http://schemas.microsoft.com/office/drawing/2014/main" id="{C3D1EAFF-7D10-463B-9FB2-DD32CB95A2F6}"/>
              </a:ext>
            </a:extLst>
          </p:cNvPr>
          <p:cNvGrpSpPr/>
          <p:nvPr/>
        </p:nvGrpSpPr>
        <p:grpSpPr>
          <a:xfrm>
            <a:off x="905146" y="5982276"/>
            <a:ext cx="3860604" cy="1154804"/>
            <a:chOff x="905146" y="5982276"/>
            <a:chExt cx="3860604" cy="1154804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E5A17DB-C3BF-415A-9D76-1C4A354DB483}"/>
                </a:ext>
              </a:extLst>
            </p:cNvPr>
            <p:cNvSpPr txBox="1"/>
            <p:nvPr/>
          </p:nvSpPr>
          <p:spPr>
            <a:xfrm rot="16200000">
              <a:off x="4193318" y="6308487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15% KO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FECD5CD-41E8-41D3-A07B-7948E06D3BAA}"/>
                </a:ext>
              </a:extLst>
            </p:cNvPr>
            <p:cNvSpPr txBox="1"/>
            <p:nvPr/>
          </p:nvSpPr>
          <p:spPr>
            <a:xfrm rot="16200000">
              <a:off x="3972609" y="6322429"/>
              <a:ext cx="8739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Untreated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721CF84-541F-42EF-9113-942F2EF95958}"/>
                </a:ext>
              </a:extLst>
            </p:cNvPr>
            <p:cNvSpPr txBox="1"/>
            <p:nvPr/>
          </p:nvSpPr>
          <p:spPr>
            <a:xfrm>
              <a:off x="905146" y="6736970"/>
              <a:ext cx="8060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GAPDH</a:t>
              </a:r>
            </a:p>
            <a:p>
              <a:r>
                <a:rPr lang="en-AU" sz="1000" dirty="0"/>
                <a:t>43kDa</a:t>
              </a:r>
            </a:p>
          </p:txBody>
        </p: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85449761-760F-49E5-8839-C59CFB5C4808}"/>
                </a:ext>
              </a:extLst>
            </p:cNvPr>
            <p:cNvCxnSpPr>
              <a:cxnSpLocks/>
            </p:cNvCxnSpPr>
            <p:nvPr/>
          </p:nvCxnSpPr>
          <p:spPr>
            <a:xfrm>
              <a:off x="1447274" y="6904981"/>
              <a:ext cx="36777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2" name="Picture 11">
            <a:extLst>
              <a:ext uri="{FF2B5EF4-FFF2-40B4-BE49-F238E27FC236}">
                <a16:creationId xmlns:a16="http://schemas.microsoft.com/office/drawing/2014/main" id="{807CAA5A-8B77-4106-9942-1B47E0E045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71549" y="2250812"/>
            <a:ext cx="554784" cy="34140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7DCCB7F4-5278-4573-B27B-5F0277B51AC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42663" y="4831819"/>
            <a:ext cx="554784" cy="341406"/>
          </a:xfrm>
          <a:prstGeom prst="rect">
            <a:avLst/>
          </a:prstGeom>
        </p:spPr>
      </p:pic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27F551E6-738D-434D-9F56-02C8287E06D3}"/>
              </a:ext>
            </a:extLst>
          </p:cNvPr>
          <p:cNvCxnSpPr>
            <a:cxnSpLocks/>
          </p:cNvCxnSpPr>
          <p:nvPr/>
        </p:nvCxnSpPr>
        <p:spPr>
          <a:xfrm>
            <a:off x="4277921" y="2187194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56F20D1A-25A4-470B-8B68-41172EE29E8C}"/>
              </a:ext>
            </a:extLst>
          </p:cNvPr>
          <p:cNvCxnSpPr>
            <a:cxnSpLocks/>
          </p:cNvCxnSpPr>
          <p:nvPr/>
        </p:nvCxnSpPr>
        <p:spPr>
          <a:xfrm>
            <a:off x="4506312" y="2165796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563AE9FC-24A9-4A1A-A479-16CA963BACF4}"/>
              </a:ext>
            </a:extLst>
          </p:cNvPr>
          <p:cNvCxnSpPr>
            <a:cxnSpLocks/>
          </p:cNvCxnSpPr>
          <p:nvPr/>
        </p:nvCxnSpPr>
        <p:spPr>
          <a:xfrm>
            <a:off x="4396418" y="4701645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C8E641EF-C579-4F86-A769-3F55437040B0}"/>
              </a:ext>
            </a:extLst>
          </p:cNvPr>
          <p:cNvCxnSpPr>
            <a:cxnSpLocks/>
          </p:cNvCxnSpPr>
          <p:nvPr/>
        </p:nvCxnSpPr>
        <p:spPr>
          <a:xfrm>
            <a:off x="4625086" y="4719287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01691BFC-9E8D-4E86-8EC8-96BB533045A4}"/>
              </a:ext>
            </a:extLst>
          </p:cNvPr>
          <p:cNvCxnSpPr>
            <a:cxnSpLocks/>
          </p:cNvCxnSpPr>
          <p:nvPr/>
        </p:nvCxnSpPr>
        <p:spPr>
          <a:xfrm>
            <a:off x="4418505" y="6775670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F35D7158-AFCB-4F1A-87B6-CF8FE12F1906}"/>
              </a:ext>
            </a:extLst>
          </p:cNvPr>
          <p:cNvCxnSpPr>
            <a:cxnSpLocks/>
          </p:cNvCxnSpPr>
          <p:nvPr/>
        </p:nvCxnSpPr>
        <p:spPr>
          <a:xfrm>
            <a:off x="4642640" y="6775670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Picture 31">
            <a:extLst>
              <a:ext uri="{FF2B5EF4-FFF2-40B4-BE49-F238E27FC236}">
                <a16:creationId xmlns:a16="http://schemas.microsoft.com/office/drawing/2014/main" id="{7DCCB7F4-5278-4573-B27B-5F0277B51AC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45164" y="6868569"/>
            <a:ext cx="478602" cy="341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29715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4EB72F5-5D0E-438A-8B18-785E767918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0453" y="4039484"/>
            <a:ext cx="4302143" cy="227685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91B9096-D8AA-46BA-975B-1EADC5AF90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0453" y="6654529"/>
            <a:ext cx="4326421" cy="187773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2EB157D-4FB5-4C1B-BDB3-9C253B1C76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30003" y="2082765"/>
            <a:ext cx="4342594" cy="149273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743A2A5-1D55-46A6-86E5-E76ACEE9775C}"/>
              </a:ext>
            </a:extLst>
          </p:cNvPr>
          <p:cNvSpPr txBox="1"/>
          <p:nvPr/>
        </p:nvSpPr>
        <p:spPr>
          <a:xfrm>
            <a:off x="640080" y="640326"/>
            <a:ext cx="182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7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7F7021A-3CF2-45E6-8CD9-64E6FFF5FCFF}"/>
              </a:ext>
            </a:extLst>
          </p:cNvPr>
          <p:cNvSpPr txBox="1"/>
          <p:nvPr/>
        </p:nvSpPr>
        <p:spPr>
          <a:xfrm>
            <a:off x="613501" y="1086396"/>
            <a:ext cx="5486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1) The expression of total Caspase-7 and cleaved caspase-7 following treatment with 5%, 10% and 15% krill oil.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26EBB470-3C91-4070-990F-7E126C5CE806}"/>
              </a:ext>
            </a:extLst>
          </p:cNvPr>
          <p:cNvGrpSpPr/>
          <p:nvPr/>
        </p:nvGrpSpPr>
        <p:grpSpPr>
          <a:xfrm>
            <a:off x="748426" y="1387942"/>
            <a:ext cx="3844648" cy="1613536"/>
            <a:chOff x="748426" y="1387942"/>
            <a:chExt cx="3844648" cy="1613536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6B36660-CEEB-4441-874B-B42B95A1FDBF}"/>
                </a:ext>
              </a:extLst>
            </p:cNvPr>
            <p:cNvSpPr txBox="1"/>
            <p:nvPr/>
          </p:nvSpPr>
          <p:spPr>
            <a:xfrm rot="16200000">
              <a:off x="4020642" y="1746146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Untreate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15627F9-AF8C-4E6A-97D2-8BE00AB013CE}"/>
                </a:ext>
              </a:extLst>
            </p:cNvPr>
            <p:cNvSpPr txBox="1"/>
            <p:nvPr/>
          </p:nvSpPr>
          <p:spPr>
            <a:xfrm rot="16200000">
              <a:off x="3731489" y="1714153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5% KO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596C1D8-4927-4686-A583-6726A8DDB9FB}"/>
                </a:ext>
              </a:extLst>
            </p:cNvPr>
            <p:cNvSpPr txBox="1"/>
            <p:nvPr/>
          </p:nvSpPr>
          <p:spPr>
            <a:xfrm rot="16200000">
              <a:off x="3492246" y="1749944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10% KO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10DD376-E4BC-46FC-9308-CAD6FC9252BF}"/>
                </a:ext>
              </a:extLst>
            </p:cNvPr>
            <p:cNvSpPr txBox="1"/>
            <p:nvPr/>
          </p:nvSpPr>
          <p:spPr>
            <a:xfrm rot="16200000">
              <a:off x="3188217" y="1755053"/>
              <a:ext cx="89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15% KO</a:t>
              </a: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E57B0319-07D2-4A6B-8669-8FAD93B8937A}"/>
                </a:ext>
              </a:extLst>
            </p:cNvPr>
            <p:cNvGrpSpPr/>
            <p:nvPr/>
          </p:nvGrpSpPr>
          <p:grpSpPr>
            <a:xfrm>
              <a:off x="748426" y="2260974"/>
              <a:ext cx="867014" cy="740504"/>
              <a:chOff x="748426" y="2260974"/>
              <a:chExt cx="867014" cy="740504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E88FDE3-03B9-49BC-9C85-59CF12B7E82D}"/>
                  </a:ext>
                </a:extLst>
              </p:cNvPr>
              <p:cNvSpPr txBox="1"/>
              <p:nvPr/>
            </p:nvSpPr>
            <p:spPr>
              <a:xfrm>
                <a:off x="748426" y="2260974"/>
                <a:ext cx="80605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Total Caspase-7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DECD077-BB17-4A10-8F41-0BCB4ABEB8C9}"/>
                  </a:ext>
                </a:extLst>
              </p:cNvPr>
              <p:cNvSpPr txBox="1"/>
              <p:nvPr/>
            </p:nvSpPr>
            <p:spPr>
              <a:xfrm>
                <a:off x="748426" y="2601368"/>
                <a:ext cx="80605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Cleaved  Caspase-7</a:t>
                </a:r>
              </a:p>
            </p:txBody>
          </p: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B3F0D0B2-1B96-4CDE-B59F-672811AAD3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9680" y="2451061"/>
                <a:ext cx="365760" cy="0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>
                <a:extLst>
                  <a:ext uri="{FF2B5EF4-FFF2-40B4-BE49-F238E27FC236}">
                    <a16:creationId xmlns:a16="http://schemas.microsoft.com/office/drawing/2014/main" id="{ABB702BD-0811-4609-8A6E-FA10817301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71600" y="2792956"/>
                <a:ext cx="182880" cy="0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B44C08C9-8D52-40FF-BE4D-57BEF31C1DB2}"/>
              </a:ext>
            </a:extLst>
          </p:cNvPr>
          <p:cNvSpPr txBox="1"/>
          <p:nvPr/>
        </p:nvSpPr>
        <p:spPr>
          <a:xfrm>
            <a:off x="758100" y="3707458"/>
            <a:ext cx="5486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2) The expression of cleaved PRAP following treatment with 5%, 10% and 15% krill oil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90FC7D0-2B17-4A3B-9769-7A94A836EA99}"/>
              </a:ext>
            </a:extLst>
          </p:cNvPr>
          <p:cNvSpPr txBox="1"/>
          <p:nvPr/>
        </p:nvSpPr>
        <p:spPr>
          <a:xfrm rot="16200000">
            <a:off x="4248344" y="4682843"/>
            <a:ext cx="89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Untreate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CA6B526-A787-44CA-A688-1BB621846869}"/>
              </a:ext>
            </a:extLst>
          </p:cNvPr>
          <p:cNvSpPr txBox="1"/>
          <p:nvPr/>
        </p:nvSpPr>
        <p:spPr>
          <a:xfrm rot="16200000">
            <a:off x="4465044" y="4678793"/>
            <a:ext cx="89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5% K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B39A734-D951-407F-A7E3-12C4D9828E6D}"/>
              </a:ext>
            </a:extLst>
          </p:cNvPr>
          <p:cNvSpPr txBox="1"/>
          <p:nvPr/>
        </p:nvSpPr>
        <p:spPr>
          <a:xfrm rot="16200000">
            <a:off x="4667829" y="4714002"/>
            <a:ext cx="89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10% KO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D15F6D5-E557-4D72-9A7C-1A4E0412565B}"/>
              </a:ext>
            </a:extLst>
          </p:cNvPr>
          <p:cNvSpPr txBox="1"/>
          <p:nvPr/>
        </p:nvSpPr>
        <p:spPr>
          <a:xfrm rot="16200000">
            <a:off x="4891073" y="4673392"/>
            <a:ext cx="89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15% KO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17F7162-378D-4736-9A7C-72E5ECDB9D6F}"/>
              </a:ext>
            </a:extLst>
          </p:cNvPr>
          <p:cNvSpPr txBox="1"/>
          <p:nvPr/>
        </p:nvSpPr>
        <p:spPr>
          <a:xfrm>
            <a:off x="1029533" y="5233697"/>
            <a:ext cx="8060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Cleaved</a:t>
            </a:r>
          </a:p>
          <a:p>
            <a:r>
              <a:rPr lang="en-AU" sz="1000" dirty="0"/>
              <a:t>PRAP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A6ED207-ED00-4292-A795-5CACBB9D6685}"/>
              </a:ext>
            </a:extLst>
          </p:cNvPr>
          <p:cNvSpPr txBox="1"/>
          <p:nvPr/>
        </p:nvSpPr>
        <p:spPr>
          <a:xfrm>
            <a:off x="695960" y="6249920"/>
            <a:ext cx="5486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3) The expression of DNA/RNA damage following treatment with 5%, 10% and 15%       krill oil.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6C90C56E-D094-458F-AD50-86BAD7D26B63}"/>
              </a:ext>
            </a:extLst>
          </p:cNvPr>
          <p:cNvGrpSpPr/>
          <p:nvPr/>
        </p:nvGrpSpPr>
        <p:grpSpPr>
          <a:xfrm>
            <a:off x="811753" y="7572522"/>
            <a:ext cx="5740814" cy="1134594"/>
            <a:chOff x="695763" y="6615099"/>
            <a:chExt cx="5740814" cy="1134594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C9B1BA6E-D535-421A-9ACF-254E51272E5E}"/>
                </a:ext>
              </a:extLst>
            </p:cNvPr>
            <p:cNvGrpSpPr/>
            <p:nvPr/>
          </p:nvGrpSpPr>
          <p:grpSpPr>
            <a:xfrm>
              <a:off x="695763" y="6676192"/>
              <a:ext cx="4713703" cy="1073501"/>
              <a:chOff x="695763" y="6676192"/>
              <a:chExt cx="4713703" cy="1073501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11050BEA-8288-4D75-8203-5A79AC6158FD}"/>
                  </a:ext>
                </a:extLst>
              </p:cNvPr>
              <p:cNvSpPr txBox="1"/>
              <p:nvPr/>
            </p:nvSpPr>
            <p:spPr>
              <a:xfrm>
                <a:off x="695763" y="6877890"/>
                <a:ext cx="80605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DNA/RNA damage</a:t>
                </a:r>
              </a:p>
            </p:txBody>
          </p:sp>
          <p:cxnSp>
            <p:nvCxnSpPr>
              <p:cNvPr id="41" name="Straight Arrow Connector 40">
                <a:extLst>
                  <a:ext uri="{FF2B5EF4-FFF2-40B4-BE49-F238E27FC236}">
                    <a16:creationId xmlns:a16="http://schemas.microsoft.com/office/drawing/2014/main" id="{1407216C-A835-4D31-B81B-5BEF1174D7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6570" y="7055377"/>
                <a:ext cx="365760" cy="0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5E2F4F37-D98B-423B-9D3E-D144835924FA}"/>
                  </a:ext>
                </a:extLst>
              </p:cNvPr>
              <p:cNvSpPr txBox="1"/>
              <p:nvPr/>
            </p:nvSpPr>
            <p:spPr>
              <a:xfrm rot="16200000">
                <a:off x="4146939" y="7177260"/>
                <a:ext cx="8986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Untreated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7D6CC1BB-A30D-4821-AA9C-97B8EF67EC77}"/>
                  </a:ext>
                </a:extLst>
              </p:cNvPr>
              <p:cNvSpPr txBox="1"/>
              <p:nvPr/>
            </p:nvSpPr>
            <p:spPr>
              <a:xfrm rot="16200000">
                <a:off x="4378576" y="7002403"/>
                <a:ext cx="8986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5% KO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975CE09A-27FC-4568-8E4E-F41F1B1132CB}"/>
                  </a:ext>
                </a:extLst>
              </p:cNvPr>
              <p:cNvSpPr txBox="1"/>
              <p:nvPr/>
            </p:nvSpPr>
            <p:spPr>
              <a:xfrm rot="16200000">
                <a:off x="4599094" y="7011678"/>
                <a:ext cx="8986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10% KO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89050234-9860-4711-9C4C-B0CC5DEEB522}"/>
                  </a:ext>
                </a:extLst>
              </p:cNvPr>
              <p:cNvSpPr txBox="1"/>
              <p:nvPr/>
            </p:nvSpPr>
            <p:spPr>
              <a:xfrm rot="16200000">
                <a:off x="4837034" y="7002404"/>
                <a:ext cx="8986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15% KO</a:t>
                </a:r>
              </a:p>
            </p:txBody>
          </p:sp>
        </p:grp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95D5051-9B4C-4810-8692-0CF1841613AA}"/>
                </a:ext>
              </a:extLst>
            </p:cNvPr>
            <p:cNvSpPr txBox="1"/>
            <p:nvPr/>
          </p:nvSpPr>
          <p:spPr>
            <a:xfrm>
              <a:off x="5630523" y="6615099"/>
              <a:ext cx="8060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/>
                <a:t>DNA/RNA damage</a:t>
              </a:r>
            </a:p>
          </p:txBody>
        </p:sp>
      </p:grp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A607EB06-824E-49D5-8971-32B31FA1A28D}"/>
              </a:ext>
            </a:extLst>
          </p:cNvPr>
          <p:cNvCxnSpPr>
            <a:cxnSpLocks/>
          </p:cNvCxnSpPr>
          <p:nvPr/>
        </p:nvCxnSpPr>
        <p:spPr>
          <a:xfrm rot="10800000">
            <a:off x="5495539" y="7765081"/>
            <a:ext cx="36576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15374CE9-6BCD-4625-9791-7FB7A004E38B}"/>
              </a:ext>
            </a:extLst>
          </p:cNvPr>
          <p:cNvCxnSpPr>
            <a:cxnSpLocks/>
          </p:cNvCxnSpPr>
          <p:nvPr/>
        </p:nvCxnSpPr>
        <p:spPr>
          <a:xfrm>
            <a:off x="4512026" y="2174019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B9FE1F6F-8361-436E-AC86-3D6DAE369794}"/>
              </a:ext>
            </a:extLst>
          </p:cNvPr>
          <p:cNvCxnSpPr>
            <a:cxnSpLocks/>
          </p:cNvCxnSpPr>
          <p:nvPr/>
        </p:nvCxnSpPr>
        <p:spPr>
          <a:xfrm>
            <a:off x="4182677" y="2181718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DC4B2527-2112-4375-8368-2F936F0D2E70}"/>
              </a:ext>
            </a:extLst>
          </p:cNvPr>
          <p:cNvCxnSpPr>
            <a:cxnSpLocks/>
          </p:cNvCxnSpPr>
          <p:nvPr/>
        </p:nvCxnSpPr>
        <p:spPr>
          <a:xfrm>
            <a:off x="3899195" y="2227589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9DB634FC-F7C7-4C3E-8EE9-82DF90E8517B}"/>
              </a:ext>
            </a:extLst>
          </p:cNvPr>
          <p:cNvCxnSpPr>
            <a:cxnSpLocks/>
          </p:cNvCxnSpPr>
          <p:nvPr/>
        </p:nvCxnSpPr>
        <p:spPr>
          <a:xfrm>
            <a:off x="3608924" y="2227589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7" name="Picture 46">
            <a:extLst>
              <a:ext uri="{FF2B5EF4-FFF2-40B4-BE49-F238E27FC236}">
                <a16:creationId xmlns:a16="http://schemas.microsoft.com/office/drawing/2014/main" id="{26E151EC-58CE-4BF2-909D-70C11412AA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37346" y="2312605"/>
            <a:ext cx="1100143" cy="740502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4FF0B2BD-12C1-4A27-AF0F-FC41D836FD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13297" y="5197149"/>
            <a:ext cx="950347" cy="676379"/>
          </a:xfrm>
          <a:prstGeom prst="rect">
            <a:avLst/>
          </a:prstGeom>
        </p:spPr>
      </p:pic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19ED91F1-DC68-4873-A7BB-73D026140B77}"/>
              </a:ext>
            </a:extLst>
          </p:cNvPr>
          <p:cNvCxnSpPr>
            <a:cxnSpLocks/>
          </p:cNvCxnSpPr>
          <p:nvPr/>
        </p:nvCxnSpPr>
        <p:spPr>
          <a:xfrm>
            <a:off x="4696388" y="5158274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2163D391-875E-4FF7-AC2E-D9B7D2322605}"/>
              </a:ext>
            </a:extLst>
          </p:cNvPr>
          <p:cNvCxnSpPr>
            <a:cxnSpLocks/>
          </p:cNvCxnSpPr>
          <p:nvPr/>
        </p:nvCxnSpPr>
        <p:spPr>
          <a:xfrm>
            <a:off x="4923171" y="5160809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D5CEF7FA-660A-45A9-811C-250DD1D67034}"/>
              </a:ext>
            </a:extLst>
          </p:cNvPr>
          <p:cNvCxnSpPr>
            <a:cxnSpLocks/>
          </p:cNvCxnSpPr>
          <p:nvPr/>
        </p:nvCxnSpPr>
        <p:spPr>
          <a:xfrm>
            <a:off x="5110522" y="5164282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4F62229B-FFF1-4DA9-AAEB-1DDB425021F9}"/>
              </a:ext>
            </a:extLst>
          </p:cNvPr>
          <p:cNvCxnSpPr>
            <a:cxnSpLocks/>
          </p:cNvCxnSpPr>
          <p:nvPr/>
        </p:nvCxnSpPr>
        <p:spPr>
          <a:xfrm>
            <a:off x="5326659" y="5145265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CA5ED580-B874-4BA4-BB75-338B4D8AF2B4}"/>
              </a:ext>
            </a:extLst>
          </p:cNvPr>
          <p:cNvCxnSpPr>
            <a:cxnSpLocks/>
          </p:cNvCxnSpPr>
          <p:nvPr/>
        </p:nvCxnSpPr>
        <p:spPr>
          <a:xfrm>
            <a:off x="1700816" y="5396248"/>
            <a:ext cx="36576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D3283150-6F99-4705-A5AE-BD2FA0826CD6}"/>
              </a:ext>
            </a:extLst>
          </p:cNvPr>
          <p:cNvCxnSpPr>
            <a:cxnSpLocks/>
          </p:cNvCxnSpPr>
          <p:nvPr/>
        </p:nvCxnSpPr>
        <p:spPr>
          <a:xfrm flipV="1">
            <a:off x="4696388" y="7867247"/>
            <a:ext cx="0" cy="22496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CFB58266-181F-48B7-8030-E1C7F35C6CB9}"/>
              </a:ext>
            </a:extLst>
          </p:cNvPr>
          <p:cNvCxnSpPr>
            <a:cxnSpLocks/>
          </p:cNvCxnSpPr>
          <p:nvPr/>
        </p:nvCxnSpPr>
        <p:spPr>
          <a:xfrm flipV="1">
            <a:off x="4914366" y="7860149"/>
            <a:ext cx="0" cy="22496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D4888BAC-F16A-4B13-AF42-02093F2C5416}"/>
              </a:ext>
            </a:extLst>
          </p:cNvPr>
          <p:cNvCxnSpPr>
            <a:cxnSpLocks/>
          </p:cNvCxnSpPr>
          <p:nvPr/>
        </p:nvCxnSpPr>
        <p:spPr>
          <a:xfrm flipV="1">
            <a:off x="5127676" y="7843172"/>
            <a:ext cx="0" cy="22496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3DC3A75E-5D0B-4561-9D69-D713E536C28B}"/>
              </a:ext>
            </a:extLst>
          </p:cNvPr>
          <p:cNvCxnSpPr>
            <a:cxnSpLocks/>
          </p:cNvCxnSpPr>
          <p:nvPr/>
        </p:nvCxnSpPr>
        <p:spPr>
          <a:xfrm flipV="1">
            <a:off x="5356750" y="7812165"/>
            <a:ext cx="0" cy="22496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3" name="Picture 62">
            <a:extLst>
              <a:ext uri="{FF2B5EF4-FFF2-40B4-BE49-F238E27FC236}">
                <a16:creationId xmlns:a16="http://schemas.microsoft.com/office/drawing/2014/main" id="{E335264C-FA0B-45AF-882C-415371DC03A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45942" y="7722830"/>
            <a:ext cx="983070" cy="2249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03373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B02713A-AF25-49F5-9DC3-B9D5F3D34B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4549" y="2226230"/>
            <a:ext cx="3342462" cy="118872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EAC83B0-9B39-4F60-A927-776945B74B05}"/>
              </a:ext>
            </a:extLst>
          </p:cNvPr>
          <p:cNvSpPr txBox="1"/>
          <p:nvPr/>
        </p:nvSpPr>
        <p:spPr>
          <a:xfrm>
            <a:off x="685800" y="1295400"/>
            <a:ext cx="548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4) The expression of total GAPDH following treatment with 5%, 10% and 15% krill oil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4797979-36B9-45E1-93AE-74157123E308}"/>
              </a:ext>
            </a:extLst>
          </p:cNvPr>
          <p:cNvSpPr txBox="1"/>
          <p:nvPr/>
        </p:nvSpPr>
        <p:spPr>
          <a:xfrm>
            <a:off x="1386081" y="2575911"/>
            <a:ext cx="806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GAPDH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8638E7C1-2D9B-4108-9D49-AA80C7E102B1}"/>
              </a:ext>
            </a:extLst>
          </p:cNvPr>
          <p:cNvCxnSpPr>
            <a:cxnSpLocks/>
          </p:cNvCxnSpPr>
          <p:nvPr/>
        </p:nvCxnSpPr>
        <p:spPr>
          <a:xfrm>
            <a:off x="1894549" y="2695396"/>
            <a:ext cx="36576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06B17F75-C937-46B5-B194-67997FB7D5AF}"/>
              </a:ext>
            </a:extLst>
          </p:cNvPr>
          <p:cNvSpPr txBox="1"/>
          <p:nvPr/>
        </p:nvSpPr>
        <p:spPr>
          <a:xfrm rot="16200000">
            <a:off x="3933781" y="1906665"/>
            <a:ext cx="89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Untreate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ADEEAEA-D40C-4B07-96FD-5BC5A7CD7DB2}"/>
              </a:ext>
            </a:extLst>
          </p:cNvPr>
          <p:cNvSpPr txBox="1"/>
          <p:nvPr/>
        </p:nvSpPr>
        <p:spPr>
          <a:xfrm rot="16200000">
            <a:off x="4140178" y="1877912"/>
            <a:ext cx="89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5% K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CC3D689-E43C-4306-AE2B-682EBC238F1E}"/>
              </a:ext>
            </a:extLst>
          </p:cNvPr>
          <p:cNvSpPr txBox="1"/>
          <p:nvPr/>
        </p:nvSpPr>
        <p:spPr>
          <a:xfrm rot="16200000">
            <a:off x="4347833" y="1919588"/>
            <a:ext cx="89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10% K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DA51C36-5281-4869-9197-039CA9AC1337}"/>
              </a:ext>
            </a:extLst>
          </p:cNvPr>
          <p:cNvSpPr txBox="1"/>
          <p:nvPr/>
        </p:nvSpPr>
        <p:spPr>
          <a:xfrm rot="16200000">
            <a:off x="4519264" y="1918019"/>
            <a:ext cx="898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15% KO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C14B604-3507-4138-93DB-FE0200E2ECA1}"/>
              </a:ext>
            </a:extLst>
          </p:cNvPr>
          <p:cNvSpPr txBox="1"/>
          <p:nvPr/>
        </p:nvSpPr>
        <p:spPr>
          <a:xfrm>
            <a:off x="285227" y="3567146"/>
            <a:ext cx="65611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.</a:t>
            </a:r>
          </a:p>
          <a:p>
            <a:endParaRPr lang="en-US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99E9370-924D-44E2-AECC-3E56AE0F85C8}"/>
              </a:ext>
            </a:extLst>
          </p:cNvPr>
          <p:cNvSpPr txBox="1"/>
          <p:nvPr/>
        </p:nvSpPr>
        <p:spPr>
          <a:xfrm>
            <a:off x="577454" y="3799281"/>
            <a:ext cx="559474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 algn="just">
              <a:buAutoNum type="arabicParenBoth"/>
            </a:pPr>
            <a:r>
              <a:rPr lang="en-US" sz="1200" dirty="0"/>
              <a:t>The expression of total caspase-7 and cleaved caspase -7  analyzed by western blotting in tumours following treatment with 5%, 10% and 15% krill oil compared to the untreated group.</a:t>
            </a:r>
          </a:p>
          <a:p>
            <a:pPr marL="228600" indent="-228600" algn="just">
              <a:buAutoNum type="arabicParenBoth"/>
            </a:pPr>
            <a:endParaRPr lang="en-US" sz="1200" dirty="0"/>
          </a:p>
          <a:p>
            <a:pPr marL="231775" indent="-231775" algn="just"/>
            <a:r>
              <a:rPr lang="en-US" sz="1200" dirty="0"/>
              <a:t>(2) The expression of cleaved PRAP in tumours following treatment with 5%, 10% and 15% krill oil compared to the untreated group.</a:t>
            </a:r>
          </a:p>
          <a:p>
            <a:pPr algn="just"/>
            <a:endParaRPr lang="en-US" sz="1200" dirty="0"/>
          </a:p>
          <a:p>
            <a:pPr marL="231775" indent="-231775" algn="just"/>
            <a:r>
              <a:rPr lang="en-US" sz="1200" dirty="0"/>
              <a:t>(3) The expression of DNA/RNA damage in tumours following treatment with 5%, 10% and 15% krill oil compared to the untreated group.  </a:t>
            </a:r>
          </a:p>
          <a:p>
            <a:pPr algn="just"/>
            <a:endParaRPr lang="en-US" sz="1200" dirty="0"/>
          </a:p>
          <a:p>
            <a:pPr marL="231775" indent="-231775" algn="just"/>
            <a:r>
              <a:rPr lang="en-US" sz="1200" dirty="0"/>
              <a:t>(4) The expression of GAPDH  analyzed by western blotting in tumours following treatment with 5%, 10% and 15% krill oil compared to the untreated group.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CFDFAC3E-735C-4963-A24C-EC4919021EE7}"/>
              </a:ext>
            </a:extLst>
          </p:cNvPr>
          <p:cNvCxnSpPr>
            <a:cxnSpLocks/>
          </p:cNvCxnSpPr>
          <p:nvPr/>
        </p:nvCxnSpPr>
        <p:spPr>
          <a:xfrm>
            <a:off x="4975645" y="2405127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C6E31BF1-922A-4B2B-A34C-C8C1B47168B0}"/>
              </a:ext>
            </a:extLst>
          </p:cNvPr>
          <p:cNvCxnSpPr>
            <a:cxnSpLocks/>
          </p:cNvCxnSpPr>
          <p:nvPr/>
        </p:nvCxnSpPr>
        <p:spPr>
          <a:xfrm>
            <a:off x="4805804" y="2418953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DF9B3535-A088-4EA9-A785-D17F0022236D}"/>
              </a:ext>
            </a:extLst>
          </p:cNvPr>
          <p:cNvCxnSpPr>
            <a:cxnSpLocks/>
          </p:cNvCxnSpPr>
          <p:nvPr/>
        </p:nvCxnSpPr>
        <p:spPr>
          <a:xfrm>
            <a:off x="4600919" y="2405879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9D4F85A4-3339-4C20-8F0D-6A980B02261E}"/>
              </a:ext>
            </a:extLst>
          </p:cNvPr>
          <p:cNvCxnSpPr>
            <a:cxnSpLocks/>
          </p:cNvCxnSpPr>
          <p:nvPr/>
        </p:nvCxnSpPr>
        <p:spPr>
          <a:xfrm>
            <a:off x="4388852" y="2411899"/>
            <a:ext cx="9228" cy="17003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>
            <a:extLst>
              <a:ext uri="{FF2B5EF4-FFF2-40B4-BE49-F238E27FC236}">
                <a16:creationId xmlns:a16="http://schemas.microsoft.com/office/drawing/2014/main" id="{9255EC75-8DF3-4503-9109-675F4C5F09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85953" y="2532128"/>
            <a:ext cx="845222" cy="193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5131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3</TotalTime>
  <Words>558</Words>
  <Application>Microsoft Office PowerPoint</Application>
  <PresentationFormat>A4 Paper (210x297 mm)</PresentationFormat>
  <Paragraphs>7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sith jayasekara</dc:creator>
  <cp:lastModifiedBy>Risith Jayasekara</cp:lastModifiedBy>
  <cp:revision>51</cp:revision>
  <dcterms:created xsi:type="dcterms:W3CDTF">2021-08-21T16:08:11Z</dcterms:created>
  <dcterms:modified xsi:type="dcterms:W3CDTF">2021-12-20T05:44:26Z</dcterms:modified>
</cp:coreProperties>
</file>